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  <p:sldId id="258" r:id="rId4"/>
    <p:sldId id="259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2" autoAdjust="0"/>
    <p:restoredTop sz="94680" autoAdjust="0"/>
  </p:normalViewPr>
  <p:slideViewPr>
    <p:cSldViewPr>
      <p:cViewPr varScale="1">
        <p:scale>
          <a:sx n="68" d="100"/>
          <a:sy n="68" d="100"/>
        </p:scale>
        <p:origin x="1446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476F3-5E5F-4609-A0D2-3B9F0298C9B2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2E916-4298-4000-9E76-53754B20934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56409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476F3-5E5F-4609-A0D2-3B9F0298C9B2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2E916-4298-4000-9E76-53754B20934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6843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476F3-5E5F-4609-A0D2-3B9F0298C9B2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2E916-4298-4000-9E76-53754B20934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1854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476F3-5E5F-4609-A0D2-3B9F0298C9B2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2E916-4298-4000-9E76-53754B20934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2727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476F3-5E5F-4609-A0D2-3B9F0298C9B2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2E916-4298-4000-9E76-53754B20934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03803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476F3-5E5F-4609-A0D2-3B9F0298C9B2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2E916-4298-4000-9E76-53754B20934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88735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476F3-5E5F-4609-A0D2-3B9F0298C9B2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2E916-4298-4000-9E76-53754B20934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3071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476F3-5E5F-4609-A0D2-3B9F0298C9B2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2E916-4298-4000-9E76-53754B20934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51884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476F3-5E5F-4609-A0D2-3B9F0298C9B2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2E916-4298-4000-9E76-53754B20934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20124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476F3-5E5F-4609-A0D2-3B9F0298C9B2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2E916-4298-4000-9E76-53754B20934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3588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476F3-5E5F-4609-A0D2-3B9F0298C9B2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2E916-4298-4000-9E76-53754B20934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4470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D476F3-5E5F-4609-A0D2-3B9F0298C9B2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A2E916-4298-4000-9E76-53754B20934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85703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09600" y="5924550"/>
            <a:ext cx="81534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Hierarchical clustering of proteins differentially expressed by PCB compared to glutamate treatment (three replicates per each condition). Red and green colors mean up- and down-regulated, respectively.</a:t>
            </a: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2455" y="457201"/>
            <a:ext cx="3967346" cy="54130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001402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7134" y="457200"/>
            <a:ext cx="4400550" cy="45726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609600" y="5334000"/>
            <a:ext cx="832109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Differential expresion for 19 proteins after PCB treatment in relation to glutamate changes. Columns G1-G3 (glutamate-treated replicates) and P1-P3 (PCB-treated replicates) show the abundance (logarithmic value) for each protein. Red lines and blue lines show the Up- and Down-regulated proteins). </a:t>
            </a:r>
          </a:p>
        </p:txBody>
      </p:sp>
      <p:sp>
        <p:nvSpPr>
          <p:cNvPr id="2" name="TextBox 1"/>
          <p:cNvSpPr txBox="1"/>
          <p:nvPr/>
        </p:nvSpPr>
        <p:spPr>
          <a:xfrm rot="16200000">
            <a:off x="1707832" y="2691170"/>
            <a:ext cx="17892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Log</a:t>
            </a:r>
            <a:r>
              <a:rPr lang="en-US" baseline="-25000"/>
              <a:t>10</a:t>
            </a:r>
            <a:r>
              <a:rPr lang="en-US"/>
              <a:t> Abundance</a:t>
            </a:r>
          </a:p>
        </p:txBody>
      </p:sp>
    </p:spTree>
    <p:extLst>
      <p:ext uri="{BB962C8B-B14F-4D97-AF65-F5344CB8AC3E}">
        <p14:creationId xmlns:p14="http://schemas.microsoft.com/office/powerpoint/2010/main" val="18911777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1599" y="1095868"/>
            <a:ext cx="3124201" cy="3552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457198" y="4724400"/>
            <a:ext cx="842933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(A) PCA analysis of protein cell extracts after PCB treatment versus control cells that demonstrate how different are both groups; red and blue squares correspond to PCB-treated and non-treated replicates, respectively.  (B) Volcano plot showing the proteins differentialy expressed (p&lt;0.05) after PCB treatment in comparison to control cells. 156 proteins were down-regulated while 146 proteins were up-regulated with the treatment. Abscissas are –log</a:t>
            </a:r>
            <a:r>
              <a:rPr lang="en-US" baseline="-25000"/>
              <a:t>10</a:t>
            </a:r>
            <a:r>
              <a:rPr lang="en-US"/>
              <a:t> (p-value) versus log</a:t>
            </a:r>
            <a:r>
              <a:rPr lang="en-US" baseline="-25000"/>
              <a:t>2</a:t>
            </a:r>
            <a:r>
              <a:rPr lang="en-US"/>
              <a:t> (fold-change).</a:t>
            </a:r>
          </a:p>
        </p:txBody>
      </p:sp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8211" y="1257300"/>
            <a:ext cx="4026189" cy="33147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301836" y="1307068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(A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492836" y="1307068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29304723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09600" y="5639395"/>
            <a:ext cx="81534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Hierarchical clustering of proteins differentially expressed by PCB treatment compared to control cells (three replicates per each condition). Up- and down-regulated genes are in blue and pink colors, respectively. </a:t>
            </a: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6000" y="304800"/>
            <a:ext cx="4230967" cy="53435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09296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6</TotalTime>
  <Words>205</Words>
  <Application>Microsoft Office PowerPoint</Application>
  <PresentationFormat>Presentación en pantalla (4:3)</PresentationFormat>
  <Paragraphs>7</Paragraphs>
  <Slides>4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VBesada</dc:creator>
  <cp:lastModifiedBy>GISELLE</cp:lastModifiedBy>
  <cp:revision>17</cp:revision>
  <dcterms:created xsi:type="dcterms:W3CDTF">2023-07-27T16:29:08Z</dcterms:created>
  <dcterms:modified xsi:type="dcterms:W3CDTF">2023-08-02T20:53:02Z</dcterms:modified>
</cp:coreProperties>
</file>